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943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437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392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146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585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327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631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843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882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439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521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9D2DB-8B66-4DE6-BA96-7251F81926B9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8056EA-A2DD-40C7-8576-7DA368B6F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563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096819" y="243654"/>
            <a:ext cx="9223787" cy="6370692"/>
            <a:chOff x="-56466" y="836999"/>
            <a:chExt cx="8849592" cy="6043227"/>
          </a:xfrm>
        </p:grpSpPr>
        <p:grpSp>
          <p:nvGrpSpPr>
            <p:cNvPr id="5" name="Group 15"/>
            <p:cNvGrpSpPr>
              <a:grpSpLocks/>
            </p:cNvGrpSpPr>
            <p:nvPr/>
          </p:nvGrpSpPr>
          <p:grpSpPr bwMode="auto">
            <a:xfrm>
              <a:off x="0" y="836999"/>
              <a:ext cx="8793126" cy="6043227"/>
              <a:chOff x="0" y="533400"/>
              <a:chExt cx="8793126" cy="6347460"/>
            </a:xfrm>
          </p:grpSpPr>
          <p:pic>
            <p:nvPicPr>
              <p:cNvPr id="15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083" t="38461" r="40263" b="14285"/>
              <a:stretch>
                <a:fillRect/>
              </a:stretch>
            </p:blipFill>
            <p:spPr bwMode="auto">
              <a:xfrm>
                <a:off x="152400" y="641419"/>
                <a:ext cx="3657600" cy="297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6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717" t="38461" r="40044" b="15385"/>
              <a:stretch>
                <a:fillRect/>
              </a:stretch>
            </p:blipFill>
            <p:spPr bwMode="auto">
              <a:xfrm>
                <a:off x="0" y="3680460"/>
                <a:ext cx="4114800" cy="3200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7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083" t="38461" r="40263" b="14285"/>
              <a:stretch>
                <a:fillRect/>
              </a:stretch>
            </p:blipFill>
            <p:spPr bwMode="auto">
              <a:xfrm>
                <a:off x="4800600" y="533400"/>
                <a:ext cx="3992526" cy="304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" name="Picture 8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762" t="34715" r="34296" b="55074"/>
              <a:stretch>
                <a:fillRect/>
              </a:stretch>
            </p:blipFill>
            <p:spPr bwMode="auto">
              <a:xfrm>
                <a:off x="7361238" y="1038368"/>
                <a:ext cx="1371600" cy="6216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" name="Rectangle 18"/>
              <p:cNvSpPr/>
              <p:nvPr/>
            </p:nvSpPr>
            <p:spPr>
              <a:xfrm>
                <a:off x="3962400" y="686397"/>
                <a:ext cx="381000" cy="56858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dirty="0"/>
              </a:p>
            </p:txBody>
          </p:sp>
          <p:grpSp>
            <p:nvGrpSpPr>
              <p:cNvPr id="20" name="Group 11"/>
              <p:cNvGrpSpPr>
                <a:grpSpLocks/>
              </p:cNvGrpSpPr>
              <p:nvPr/>
            </p:nvGrpSpPr>
            <p:grpSpPr bwMode="auto">
              <a:xfrm>
                <a:off x="3242487" y="685800"/>
                <a:ext cx="910413" cy="685906"/>
                <a:chOff x="3695700" y="2286000"/>
                <a:chExt cx="876300" cy="569116"/>
              </a:xfrm>
            </p:grpSpPr>
            <p:pic>
              <p:nvPicPr>
                <p:cNvPr id="21" name="Picture 12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1762" t="44363" r="45558" b="45586"/>
                <a:stretch>
                  <a:fillRect/>
                </a:stretch>
              </p:blipFill>
              <p:spPr bwMode="auto">
                <a:xfrm>
                  <a:off x="3695700" y="2286000"/>
                  <a:ext cx="304800" cy="56902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2" name="Rectangle 21"/>
                <p:cNvSpPr/>
                <p:nvPr/>
              </p:nvSpPr>
              <p:spPr>
                <a:xfrm>
                  <a:off x="4000522" y="2286496"/>
                  <a:ext cx="380477" cy="56862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/>
                </a:p>
              </p:txBody>
            </p:sp>
            <p:pic>
              <p:nvPicPr>
                <p:cNvPr id="23" name="Picture 14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224" t="44363" r="36853" b="46214"/>
                <a:stretch>
                  <a:fillRect/>
                </a:stretch>
              </p:blipFill>
              <p:spPr bwMode="auto">
                <a:xfrm>
                  <a:off x="4011930" y="2298395"/>
                  <a:ext cx="560070" cy="5334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</p:grpSp>
        <p:grpSp>
          <p:nvGrpSpPr>
            <p:cNvPr id="6" name="Group 18"/>
            <p:cNvGrpSpPr>
              <a:grpSpLocks/>
            </p:cNvGrpSpPr>
            <p:nvPr/>
          </p:nvGrpSpPr>
          <p:grpSpPr bwMode="auto">
            <a:xfrm>
              <a:off x="3178175" y="4525963"/>
              <a:ext cx="762000" cy="699302"/>
              <a:chOff x="2209800" y="1981200"/>
              <a:chExt cx="1066800" cy="861459"/>
            </a:xfrm>
          </p:grpSpPr>
          <p:pic>
            <p:nvPicPr>
              <p:cNvPr id="13" name="Picture 19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762" t="54013" r="45667" b="35736"/>
              <a:stretch>
                <a:fillRect/>
              </a:stretch>
            </p:blipFill>
            <p:spPr bwMode="auto">
              <a:xfrm>
                <a:off x="2209800" y="1981200"/>
                <a:ext cx="381000" cy="8096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4" name="Picture 20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932" t="54013" r="37444" b="35736"/>
              <a:stretch>
                <a:fillRect/>
              </a:stretch>
            </p:blipFill>
            <p:spPr bwMode="auto">
              <a:xfrm>
                <a:off x="2590800" y="2033034"/>
                <a:ext cx="685800" cy="8096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7" name="TextBox 6"/>
            <p:cNvSpPr txBox="1"/>
            <p:nvPr/>
          </p:nvSpPr>
          <p:spPr>
            <a:xfrm>
              <a:off x="2124979" y="836999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baseline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487136" y="890618"/>
              <a:ext cx="11076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roximal colon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137354" y="3903866"/>
              <a:ext cx="6916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 weeks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-56466" y="927251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-53354" y="4042365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746301" y="996317"/>
              <a:ext cx="294245" cy="350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728947" y="4206949"/>
            <a:ext cx="6261651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Bacterial community beta diversity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mparison of fecal bacterial 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sition at baseline (A),six weeks after dietary treatment (B) and among colonic 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l composition at the end of dietary intervention with control, 3 servings 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6 servings of mushroom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206477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6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lano-Aguilar, Gloria</dc:creator>
  <cp:lastModifiedBy>Solano-Aguilar, Gloria</cp:lastModifiedBy>
  <cp:revision>4</cp:revision>
  <dcterms:created xsi:type="dcterms:W3CDTF">2018-09-19T22:01:18Z</dcterms:created>
  <dcterms:modified xsi:type="dcterms:W3CDTF">2018-11-07T23:12:30Z</dcterms:modified>
</cp:coreProperties>
</file>